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0"/>
    <p:restoredTop sz="94663"/>
  </p:normalViewPr>
  <p:slideViewPr>
    <p:cSldViewPr snapToGrid="0" snapToObjects="1">
      <p:cViewPr varScale="1">
        <p:scale>
          <a:sx n="115" d="100"/>
          <a:sy n="115" d="100"/>
        </p:scale>
        <p:origin x="39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F2C808-FEE8-7549-88B4-8397EE2F41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67EF85-7BBA-4142-BDED-9CE22FB267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3130E5-BA00-3347-8361-C86F7B343A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56EFB-7A17-C24A-8C9C-5FA22DC1987B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4756A6-7CD8-2849-AE8F-2B9B2841B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25D5BE-64BF-3141-B7A1-2B93301E3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1FE56-DDE8-3740-9A84-A6EAA64F8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476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310E36-1F19-CF4D-BAD1-660F1E8BF4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BBAF2C-5347-7944-BC21-F32DE3A2F0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376E03-E9AD-814E-B4CF-AB32BC986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56EFB-7A17-C24A-8C9C-5FA22DC1987B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12CD1A-4C56-E74E-99A1-D72D2DEBF8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5CB39F-C8BC-134B-91CC-6D4B62770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1FE56-DDE8-3740-9A84-A6EAA64F8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665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126A0B-6C47-AC43-B6BB-33FC86F00E4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055B44-3275-4A49-8FFC-A47BE206AB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070699-3899-F448-94E2-6F5E01E3D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56EFB-7A17-C24A-8C9C-5FA22DC1987B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9E05E5-3BE9-194E-911D-455B558FC1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3A9D7-8039-C648-8EFA-43CE971EA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1FE56-DDE8-3740-9A84-A6EAA64F8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722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77FE0E-3E28-2944-B152-A3107351D7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4AEAA6-0AFB-4242-A9DA-28C353D284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451761-20B8-CE42-A22A-0066C6953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56EFB-7A17-C24A-8C9C-5FA22DC1987B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8CC0A1-FAE5-9D4C-86CC-536CA13B2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D91F7F-6822-2A49-884B-B7343EB9A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1FE56-DDE8-3740-9A84-A6EAA64F8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812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DB83A5-B00C-AC4D-85A0-A23FBD32D4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FB21D2-144F-E44A-BF1F-64C77055B9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6E2B58-4946-9E42-9FB0-555CA37E0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56EFB-7A17-C24A-8C9C-5FA22DC1987B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2B6F09-13CD-3C46-B9CF-75649F26E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4A3260-A6F3-3D4E-8514-1A440B6FC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1FE56-DDE8-3740-9A84-A6EAA64F8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961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453804-51E2-1640-A2B4-7DB7166CD4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CD9844-7703-424A-A441-F8303003CCD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6BF34F-AD99-524F-8634-5CEB18E662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400FC5-B542-6047-9F82-EF1304CA51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56EFB-7A17-C24A-8C9C-5FA22DC1987B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9A0238-D19B-1C4E-88DF-522E57210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3AB2D6-6013-7040-824A-03767DFC1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1FE56-DDE8-3740-9A84-A6EAA64F8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071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CE4B78-7EA6-704F-A2F5-22018FF26F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145768-62A7-3644-9C91-CE867F5C00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731F2D-1D2E-8E40-BE98-335516DCCD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446926-A757-8943-B564-26448AFD04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D3283C-B999-D245-83AF-53C8C0C7E7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A112C72-7ED8-5643-B381-41422C11F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56EFB-7A17-C24A-8C9C-5FA22DC1987B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1949376-41F0-CB4A-8409-34E6C48EE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5F855E4-5134-FA40-AB30-8C379AFD1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1FE56-DDE8-3740-9A84-A6EAA64F8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178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2235A-6F80-E542-93EB-04341E02C2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AB019F-7CE8-6247-82DB-A72A69052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56EFB-7A17-C24A-8C9C-5FA22DC1987B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CB5500-0140-2E47-9E13-AE540C485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3BFF604-6C3A-2E42-97C3-F9559B760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1FE56-DDE8-3740-9A84-A6EAA64F8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972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ED2577C-D328-3740-B80F-48E90912BB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56EFB-7A17-C24A-8C9C-5FA22DC1987B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4B94DF9-E7FD-2443-AE4A-5D3F50D05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1008F8D-83C5-5C4F-8BE9-93039BD173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1FE56-DDE8-3740-9A84-A6EAA64F8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614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BCFD2F-4805-FA48-BD20-56AEF78AE2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1476A2-F893-4F4B-8A0C-D3743E0F33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707A57-AC68-9D4A-9358-ADD859CE2F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A894FC-B59F-8E42-B4B5-E13BBF4E89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56EFB-7A17-C24A-8C9C-5FA22DC1987B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91BCD5-F6E7-E944-8132-AA352AD8D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2B338D-53AF-EA42-8019-876FDAFDB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1FE56-DDE8-3740-9A84-A6EAA64F8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62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89C293-6B4E-FE44-8BC7-98976719EE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44DDA08-119E-EC4B-8E19-FDB7E6D009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FF0012-97CB-824A-AFAE-4AD210DA08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418DCB-E933-1343-A913-04C87777C5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56EFB-7A17-C24A-8C9C-5FA22DC1987B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9F4220-BAD1-0C4A-BA2E-310B6AF306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592E7C-55B3-5749-A90F-AB36FBFCF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1FE56-DDE8-3740-9A84-A6EAA64F8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82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4911B3B-DBA9-F34E-87EE-31511184F9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4E9D49-D807-5645-8ABB-0D8EB304C6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CC7419-8B0F-8640-AA67-0AFD0FE6FA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56EFB-7A17-C24A-8C9C-5FA22DC1987B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297E9C-F051-074B-92A8-142E7B76AD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D1BACB-0501-5144-92CD-32F9FABC0E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51FE56-DDE8-3740-9A84-A6EAA64F8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619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ECA658D-3AEC-4945-BC86-4D5A6C81B543}"/>
              </a:ext>
            </a:extLst>
          </p:cNvPr>
          <p:cNvSpPr txBox="1"/>
          <p:nvPr/>
        </p:nvSpPr>
        <p:spPr>
          <a:xfrm>
            <a:off x="4002554" y="4137092"/>
            <a:ext cx="9565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1</a:t>
            </a:r>
            <a:r>
              <a:rPr lang="en-US" sz="1400" b="1" baseline="30000" dirty="0"/>
              <a:t>st</a:t>
            </a:r>
            <a:r>
              <a:rPr lang="en-US" sz="1400" b="1" dirty="0"/>
              <a:t> vaccin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574B761-CBBA-C94A-950C-BE0DA7177C21}"/>
              </a:ext>
            </a:extLst>
          </p:cNvPr>
          <p:cNvSpPr txBox="1"/>
          <p:nvPr/>
        </p:nvSpPr>
        <p:spPr>
          <a:xfrm>
            <a:off x="7385526" y="4137092"/>
            <a:ext cx="10604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2nd vaccin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97AC94E-8352-0640-81A5-30BF65B6F9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0235" y="782760"/>
            <a:ext cx="3211821" cy="327384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12BC9A9-47E7-214E-85F6-FD7E2849B8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58303" y="828449"/>
            <a:ext cx="3211821" cy="3182465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567A5186-F733-634D-BFBF-64D93BF12852}"/>
              </a:ext>
            </a:extLst>
          </p:cNvPr>
          <p:cNvSpPr/>
          <p:nvPr/>
        </p:nvSpPr>
        <p:spPr>
          <a:xfrm>
            <a:off x="2229870" y="147310"/>
            <a:ext cx="7224372" cy="4424855"/>
          </a:xfrm>
          <a:prstGeom prst="rect">
            <a:avLst/>
          </a:prstGeom>
          <a:solidFill>
            <a:srgbClr val="FFF7E7">
              <a:alpha val="2665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1D787F35-0AEE-4049-8587-8F29F32F28BB}"/>
              </a:ext>
            </a:extLst>
          </p:cNvPr>
          <p:cNvSpPr txBox="1">
            <a:spLocks/>
          </p:cNvSpPr>
          <p:nvPr/>
        </p:nvSpPr>
        <p:spPr>
          <a:xfrm>
            <a:off x="4480826" y="4588451"/>
            <a:ext cx="2976812" cy="40568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/>
              <a:t>Supplementary Figure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4C6D272-984A-0F4A-A44F-D61642868809}"/>
              </a:ext>
            </a:extLst>
          </p:cNvPr>
          <p:cNvSpPr txBox="1"/>
          <p:nvPr/>
        </p:nvSpPr>
        <p:spPr>
          <a:xfrm>
            <a:off x="2362200" y="290747"/>
            <a:ext cx="268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DA37466-E2D8-FE4C-9F64-BDB38DA7F577}"/>
              </a:ext>
            </a:extLst>
          </p:cNvPr>
          <p:cNvSpPr txBox="1"/>
          <p:nvPr/>
        </p:nvSpPr>
        <p:spPr>
          <a:xfrm>
            <a:off x="5969232" y="267198"/>
            <a:ext cx="290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" name="Rectangle 1"/>
          <p:cNvSpPr/>
          <p:nvPr/>
        </p:nvSpPr>
        <p:spPr>
          <a:xfrm>
            <a:off x="489313" y="5274909"/>
            <a:ext cx="1124989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Correlation between antibody response to SARS-CoV-2 spike following first and second vaccine and time since original diagnosis of CLL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tibodies were measured by Roche assay on serum samples. 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96477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Parry (School of Immunity and Infection)</dc:creator>
  <cp:lastModifiedBy>Helen Parry (School of Immunity and Infection)</cp:lastModifiedBy>
  <cp:revision>2</cp:revision>
  <dcterms:created xsi:type="dcterms:W3CDTF">2021-07-05T12:01:00Z</dcterms:created>
  <dcterms:modified xsi:type="dcterms:W3CDTF">2021-07-06T14:08:14Z</dcterms:modified>
</cp:coreProperties>
</file>